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71" r:id="rId2"/>
    <p:sldId id="289" r:id="rId3"/>
    <p:sldId id="278" r:id="rId4"/>
    <p:sldId id="290" r:id="rId5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562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86"/>
    <p:restoredTop sz="95304" autoAdjust="0"/>
  </p:normalViewPr>
  <p:slideViewPr>
    <p:cSldViewPr snapToObjects="1">
      <p:cViewPr varScale="1">
        <p:scale>
          <a:sx n="109" d="100"/>
          <a:sy n="109" d="100"/>
        </p:scale>
        <p:origin x="3604" y="10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2" d="100"/>
        <a:sy n="10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kanokazuhisa:Library:Containers:com.apple.mail:Data:Library:Mail%20Downloads:143C858A-F5E5-4CB2-B1ED-E97E3037C981:20161208-TET3-mRNA&#20998;&#35299;-&#32113;&#35336;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kanokazuhisa:Documents:UOEH%20&#23455;&#39443;&#38306;&#20418;:Research:MeKN:MeKN052%20qPCR%20TETs%20siRNA:MeKN052%20qPCR%20TETs%20siRNA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https://d.docs.live.net/8d3e39ca26029099/&#12487;&#12473;&#12463;&#12488;&#12483;&#12503;/&#27827;&#37002;ART/FLS&#22679;&#27542;&#12487;&#12540;&#12479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グラフ!$B$2</c:f>
              <c:strCache>
                <c:ptCount val="1"/>
                <c:pt idx="0">
                  <c:v>TNF-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グラフ!$C$6:$G$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4572478843884301E-2</c:v>
                  </c:pt>
                  <c:pt idx="2">
                    <c:v>0.127854285675396</c:v>
                  </c:pt>
                  <c:pt idx="3">
                    <c:v>8.7007248192105702E-2</c:v>
                  </c:pt>
                  <c:pt idx="4">
                    <c:v>0.132077999368165</c:v>
                  </c:pt>
                </c:numCache>
              </c:numRef>
            </c:plus>
            <c:minus>
              <c:numRef>
                <c:f>グラフ!$C$6:$G$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4572478843884301E-2</c:v>
                  </c:pt>
                  <c:pt idx="2">
                    <c:v>0.127854285675396</c:v>
                  </c:pt>
                  <c:pt idx="3">
                    <c:v>8.7007248192105702E-2</c:v>
                  </c:pt>
                  <c:pt idx="4">
                    <c:v>0.132077999368165</c:v>
                  </c:pt>
                </c:numCache>
              </c:numRef>
            </c:minus>
          </c:errBars>
          <c:cat>
            <c:numRef>
              <c:f>グラフ!$C$1:$G$1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6</c:v>
                </c:pt>
              </c:numCache>
            </c:numRef>
          </c:cat>
          <c:val>
            <c:numRef>
              <c:f>グラフ!$C$2:$G$2</c:f>
              <c:numCache>
                <c:formatCode>General</c:formatCode>
                <c:ptCount val="5"/>
                <c:pt idx="0">
                  <c:v>1</c:v>
                </c:pt>
                <c:pt idx="1">
                  <c:v>0.82521186761060294</c:v>
                </c:pt>
                <c:pt idx="2">
                  <c:v>0.74833852039945503</c:v>
                </c:pt>
                <c:pt idx="3">
                  <c:v>0.61705102774269505</c:v>
                </c:pt>
                <c:pt idx="4">
                  <c:v>0.576603733049435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2E-8B47-86F5-5D588B557F4E}"/>
            </c:ext>
          </c:extLst>
        </c:ser>
        <c:ser>
          <c:idx val="1"/>
          <c:order val="1"/>
          <c:tx>
            <c:strRef>
              <c:f>グラフ!$B$3</c:f>
              <c:strCache>
                <c:ptCount val="1"/>
                <c:pt idx="0">
                  <c:v>TNF+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グラフ!$C$7:$G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9253966436410899E-2</c:v>
                  </c:pt>
                  <c:pt idx="2">
                    <c:v>0.15254180263150199</c:v>
                  </c:pt>
                  <c:pt idx="3">
                    <c:v>6.0459957605902198E-2</c:v>
                  </c:pt>
                  <c:pt idx="4">
                    <c:v>0.21632946351874399</c:v>
                  </c:pt>
                </c:numCache>
              </c:numRef>
            </c:plus>
            <c:minus>
              <c:numRef>
                <c:f>グラフ!$C$7:$G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9253966436410899E-2</c:v>
                  </c:pt>
                  <c:pt idx="2">
                    <c:v>0.15254180263150199</c:v>
                  </c:pt>
                  <c:pt idx="3">
                    <c:v>6.0459957605902198E-2</c:v>
                  </c:pt>
                  <c:pt idx="4">
                    <c:v>0.21632946351874399</c:v>
                  </c:pt>
                </c:numCache>
              </c:numRef>
            </c:minus>
          </c:errBars>
          <c:cat>
            <c:numRef>
              <c:f>グラフ!$C$1:$G$1</c:f>
              <c:numCache>
                <c:formatCode>General</c:formatCode>
                <c:ptCount val="5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6</c:v>
                </c:pt>
              </c:numCache>
            </c:numRef>
          </c:cat>
          <c:val>
            <c:numRef>
              <c:f>グラフ!$C$3:$G$3</c:f>
              <c:numCache>
                <c:formatCode>General</c:formatCode>
                <c:ptCount val="5"/>
                <c:pt idx="0">
                  <c:v>1</c:v>
                </c:pt>
                <c:pt idx="1">
                  <c:v>0.75772264595080596</c:v>
                </c:pt>
                <c:pt idx="2">
                  <c:v>0.831718345427643</c:v>
                </c:pt>
                <c:pt idx="3">
                  <c:v>0.56230126327510799</c:v>
                </c:pt>
                <c:pt idx="4">
                  <c:v>0.726243875964062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92E-8B47-86F5-5D588B557F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8498712"/>
        <c:axId val="-2088505480"/>
      </c:barChart>
      <c:catAx>
        <c:axId val="-2088498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800">
                <a:noFill/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-2088505480"/>
        <c:crosses val="autoZero"/>
        <c:auto val="1"/>
        <c:lblAlgn val="ctr"/>
        <c:lblOffset val="100"/>
        <c:noMultiLvlLbl val="0"/>
      </c:catAx>
      <c:valAx>
        <c:axId val="-2088505480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noFill/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-2088498712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26</c:f>
              <c:strCache>
                <c:ptCount val="1"/>
                <c:pt idx="0">
                  <c:v>siCT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O$31:$O$33</c:f>
                <c:numCache>
                  <c:formatCode>General</c:formatCode>
                  <c:ptCount val="3"/>
                  <c:pt idx="0">
                    <c:v>5.7267505647499703E-2</c:v>
                  </c:pt>
                  <c:pt idx="1">
                    <c:v>6.06718600870636E-2</c:v>
                  </c:pt>
                  <c:pt idx="2">
                    <c:v>5.9181007163517797E-2</c:v>
                  </c:pt>
                </c:numCache>
              </c:numRef>
            </c:plus>
            <c:minus>
              <c:numRef>
                <c:f>Sheet1!$O$31:$O$33</c:f>
                <c:numCache>
                  <c:formatCode>General</c:formatCode>
                  <c:ptCount val="3"/>
                  <c:pt idx="0">
                    <c:v>5.7267505647499703E-2</c:v>
                  </c:pt>
                  <c:pt idx="1">
                    <c:v>6.06718600870636E-2</c:v>
                  </c:pt>
                  <c:pt idx="2">
                    <c:v>5.9181007163517797E-2</c:v>
                  </c:pt>
                </c:numCache>
              </c:numRef>
            </c:minus>
          </c:errBars>
          <c:cat>
            <c:strRef>
              <c:f>Sheet1!$N$27:$N$29</c:f>
              <c:strCache>
                <c:ptCount val="3"/>
                <c:pt idx="0">
                  <c:v>TET1</c:v>
                </c:pt>
                <c:pt idx="1">
                  <c:v>TET2</c:v>
                </c:pt>
                <c:pt idx="2">
                  <c:v>TET3</c:v>
                </c:pt>
              </c:strCache>
            </c:strRef>
          </c:cat>
          <c:val>
            <c:numRef>
              <c:f>Sheet1!$O$27:$O$29</c:f>
              <c:numCache>
                <c:formatCode>General</c:formatCode>
                <c:ptCount val="3"/>
                <c:pt idx="0">
                  <c:v>1.0032688776652019</c:v>
                </c:pt>
                <c:pt idx="1">
                  <c:v>1.003667612870534</c:v>
                </c:pt>
                <c:pt idx="2">
                  <c:v>1.00349018971125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20-574D-BF03-88B599D4A03C}"/>
            </c:ext>
          </c:extLst>
        </c:ser>
        <c:ser>
          <c:idx val="1"/>
          <c:order val="1"/>
          <c:tx>
            <c:strRef>
              <c:f>Sheet1!$P$26</c:f>
              <c:strCache>
                <c:ptCount val="1"/>
                <c:pt idx="0">
                  <c:v>siTET3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P$31:$P$33</c:f>
                <c:numCache>
                  <c:formatCode>General</c:formatCode>
                  <c:ptCount val="3"/>
                  <c:pt idx="0">
                    <c:v>3.7323694158354501E-2</c:v>
                  </c:pt>
                  <c:pt idx="1">
                    <c:v>5.2066629125946701E-2</c:v>
                  </c:pt>
                  <c:pt idx="2">
                    <c:v>1.0884609805020999E-2</c:v>
                  </c:pt>
                </c:numCache>
              </c:numRef>
            </c:plus>
            <c:minus>
              <c:numRef>
                <c:f>Sheet1!$P$31:$P$33</c:f>
                <c:numCache>
                  <c:formatCode>General</c:formatCode>
                  <c:ptCount val="3"/>
                  <c:pt idx="0">
                    <c:v>3.7323694158354501E-2</c:v>
                  </c:pt>
                  <c:pt idx="1">
                    <c:v>5.2066629125946701E-2</c:v>
                  </c:pt>
                  <c:pt idx="2">
                    <c:v>1.0884609805020999E-2</c:v>
                  </c:pt>
                </c:numCache>
              </c:numRef>
            </c:minus>
          </c:errBars>
          <c:cat>
            <c:strRef>
              <c:f>Sheet1!$N$27:$N$29</c:f>
              <c:strCache>
                <c:ptCount val="3"/>
                <c:pt idx="0">
                  <c:v>TET1</c:v>
                </c:pt>
                <c:pt idx="1">
                  <c:v>TET2</c:v>
                </c:pt>
                <c:pt idx="2">
                  <c:v>TET3</c:v>
                </c:pt>
              </c:strCache>
            </c:strRef>
          </c:cat>
          <c:val>
            <c:numRef>
              <c:f>Sheet1!$P$27:$P$29</c:f>
              <c:numCache>
                <c:formatCode>General</c:formatCode>
                <c:ptCount val="3"/>
                <c:pt idx="0">
                  <c:v>0.96847881873448705</c:v>
                </c:pt>
                <c:pt idx="1">
                  <c:v>1.040447195370992</c:v>
                </c:pt>
                <c:pt idx="2">
                  <c:v>0.140254211922486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620-574D-BF03-88B599D4A0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94364456"/>
        <c:axId val="-2094378056"/>
      </c:barChart>
      <c:catAx>
        <c:axId val="-209436445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900">
                <a:noFill/>
              </a:defRPr>
            </a:pPr>
            <a:endParaRPr lang="ja-JP"/>
          </a:p>
        </c:txPr>
        <c:crossAx val="-2094378056"/>
        <c:crosses val="autoZero"/>
        <c:auto val="1"/>
        <c:lblAlgn val="ctr"/>
        <c:lblOffset val="100"/>
        <c:noMultiLvlLbl val="0"/>
      </c:catAx>
      <c:valAx>
        <c:axId val="-2094378056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noFill/>
              </a:defRPr>
            </a:pPr>
            <a:endParaRPr lang="ja-JP"/>
          </a:p>
        </c:txPr>
        <c:crossAx val="-2094364456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F$8:$F$11</c:f>
                <c:numCache>
                  <c:formatCode>General</c:formatCode>
                  <c:ptCount val="4"/>
                  <c:pt idx="0">
                    <c:v>3</c:v>
                  </c:pt>
                  <c:pt idx="1">
                    <c:v>5.131601439446885</c:v>
                  </c:pt>
                  <c:pt idx="2">
                    <c:v>4.5825756949558398</c:v>
                  </c:pt>
                  <c:pt idx="3">
                    <c:v>6.24499799839839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8:$B$11</c:f>
              <c:numCache>
                <c:formatCode>General</c:formatCode>
                <c:ptCount val="4"/>
                <c:pt idx="0">
                  <c:v>7.5</c:v>
                </c:pt>
                <c:pt idx="1">
                  <c:v>9.8333333333333339</c:v>
                </c:pt>
                <c:pt idx="2">
                  <c:v>19</c:v>
                </c:pt>
                <c:pt idx="3">
                  <c:v>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02A-4368-BDC5-58FC661CB204}"/>
            </c:ext>
          </c:extLst>
        </c:ser>
        <c:ser>
          <c:idx val="1"/>
          <c:order val="1"/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8:$G$11</c:f>
                <c:numCache>
                  <c:formatCode>General</c:formatCode>
                  <c:ptCount val="4"/>
                  <c:pt idx="0">
                    <c:v>1.5</c:v>
                  </c:pt>
                  <c:pt idx="1">
                    <c:v>3</c:v>
                  </c:pt>
                  <c:pt idx="2">
                    <c:v>4.5825756949558398</c:v>
                  </c:pt>
                  <c:pt idx="3">
                    <c:v>2.29128784747791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C$8:$C$11</c:f>
              <c:numCache>
                <c:formatCode>General</c:formatCode>
                <c:ptCount val="4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02A-4368-BDC5-58FC661CB204}"/>
            </c:ext>
          </c:extLst>
        </c:ser>
        <c:ser>
          <c:idx val="2"/>
          <c:order val="2"/>
          <c:spPr>
            <a:ln w="28575" cap="sq">
              <a:solidFill>
                <a:sysClr val="windowText" lastClr="000000"/>
              </a:solidFill>
              <a:prstDash val="sysDot"/>
              <a:bevel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8:$H$11</c:f>
                <c:numCache>
                  <c:formatCode>General</c:formatCode>
                  <c:ptCount val="4"/>
                  <c:pt idx="0">
                    <c:v>1.5</c:v>
                  </c:pt>
                  <c:pt idx="1">
                    <c:v>2.0816659994661348</c:v>
                  </c:pt>
                  <c:pt idx="2">
                    <c:v>2.598076211353316</c:v>
                  </c:pt>
                  <c:pt idx="3">
                    <c:v>2.29128784747791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D$8:$D$11</c:f>
              <c:numCache>
                <c:formatCode>General</c:formatCode>
                <c:ptCount val="4"/>
                <c:pt idx="0">
                  <c:v>7.5</c:v>
                </c:pt>
                <c:pt idx="1">
                  <c:v>10.666666666666666</c:v>
                </c:pt>
                <c:pt idx="2">
                  <c:v>12</c:v>
                </c:pt>
                <c:pt idx="3">
                  <c:v>1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02A-4368-BDC5-58FC661CB2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75618640"/>
        <c:axId val="775622800"/>
      </c:lineChart>
      <c:catAx>
        <c:axId val="775618640"/>
        <c:scaling>
          <c:orientation val="minMax"/>
        </c:scaling>
        <c:delete val="1"/>
        <c:axPos val="b"/>
        <c:majorTickMark val="none"/>
        <c:minorTickMark val="none"/>
        <c:tickLblPos val="nextTo"/>
        <c:crossAx val="775622800"/>
        <c:crosses val="autoZero"/>
        <c:auto val="1"/>
        <c:lblAlgn val="ctr"/>
        <c:lblOffset val="100"/>
        <c:noMultiLvlLbl val="0"/>
      </c:catAx>
      <c:valAx>
        <c:axId val="775622800"/>
        <c:scaling>
          <c:orientation val="minMax"/>
        </c:scaling>
        <c:delete val="1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775618640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9DF7D6-F4FF-9749-9E52-0DA2507E89F7}" type="datetimeFigureOut">
              <a:rPr kumimoji="1" lang="ja-JP" altLang="en-US" smtClean="0"/>
              <a:t>2022/7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FC59B4-6616-DB47-AC63-9AFFA1382A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32409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D600A-F190-8D45-A8FC-D106BF752AAB}" type="datetimeFigureOut">
              <a:rPr kumimoji="1" lang="ja-JP" altLang="en-US" smtClean="0"/>
              <a:t>2022/7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538AA-95E3-6145-BF3A-D203A5265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174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D600A-F190-8D45-A8FC-D106BF752AAB}" type="datetimeFigureOut">
              <a:rPr kumimoji="1" lang="ja-JP" altLang="en-US" smtClean="0"/>
              <a:t>2022/7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538AA-95E3-6145-BF3A-D203A5265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1177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D600A-F190-8D45-A8FC-D106BF752AAB}" type="datetimeFigureOut">
              <a:rPr kumimoji="1" lang="ja-JP" altLang="en-US" smtClean="0"/>
              <a:t>2022/7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538AA-95E3-6145-BF3A-D203A5265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5281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D600A-F190-8D45-A8FC-D106BF752AAB}" type="datetimeFigureOut">
              <a:rPr kumimoji="1" lang="ja-JP" altLang="en-US" smtClean="0"/>
              <a:t>2022/7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538AA-95E3-6145-BF3A-D203A5265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6351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D600A-F190-8D45-A8FC-D106BF752AAB}" type="datetimeFigureOut">
              <a:rPr kumimoji="1" lang="ja-JP" altLang="en-US" smtClean="0"/>
              <a:t>2022/7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538AA-95E3-6145-BF3A-D203A5265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7188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3338694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3338694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D600A-F190-8D45-A8FC-D106BF752AAB}" type="datetimeFigureOut">
              <a:rPr kumimoji="1" lang="ja-JP" altLang="en-US" smtClean="0"/>
              <a:t>2022/7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538AA-95E3-6145-BF3A-D203A5265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2968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D600A-F190-8D45-A8FC-D106BF752AAB}" type="datetimeFigureOut">
              <a:rPr kumimoji="1" lang="ja-JP" altLang="en-US" smtClean="0"/>
              <a:t>2022/7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538AA-95E3-6145-BF3A-D203A5265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1440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D600A-F190-8D45-A8FC-D106BF752AAB}" type="datetimeFigureOut">
              <a:rPr kumimoji="1" lang="ja-JP" altLang="en-US" smtClean="0"/>
              <a:t>2022/7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538AA-95E3-6145-BF3A-D203A5265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0205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D600A-F190-8D45-A8FC-D106BF752AAB}" type="datetimeFigureOut">
              <a:rPr kumimoji="1" lang="ja-JP" altLang="en-US" smtClean="0"/>
              <a:t>2022/7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538AA-95E3-6145-BF3A-D203A5265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41073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94410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D600A-F190-8D45-A8FC-D106BF752AAB}" type="datetimeFigureOut">
              <a:rPr kumimoji="1" lang="ja-JP" altLang="en-US" smtClean="0"/>
              <a:t>2022/7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538AA-95E3-6145-BF3A-D203A5265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179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D600A-F190-8D45-A8FC-D106BF752AAB}" type="datetimeFigureOut">
              <a:rPr kumimoji="1" lang="ja-JP" altLang="en-US" smtClean="0"/>
              <a:t>2022/7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538AA-95E3-6145-BF3A-D203A5265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9522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0D600A-F190-8D45-A8FC-D106BF752AAB}" type="datetimeFigureOut">
              <a:rPr kumimoji="1" lang="ja-JP" altLang="en-US" smtClean="0"/>
              <a:t>2022/7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9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E538AA-95E3-6145-BF3A-D203A5265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3809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252172" y="402752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ja-JP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" name="グラフ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0621804"/>
              </p:ext>
            </p:extLst>
          </p:nvPr>
        </p:nvGraphicFramePr>
        <p:xfrm>
          <a:off x="508226" y="581790"/>
          <a:ext cx="2930302" cy="19385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8" name="テキスト ボックス 27"/>
          <p:cNvSpPr txBox="1"/>
          <p:nvPr/>
        </p:nvSpPr>
        <p:spPr>
          <a:xfrm>
            <a:off x="3115763" y="2275411"/>
            <a:ext cx="578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 rot="16200000">
            <a:off x="-319991" y="1299989"/>
            <a:ext cx="141737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elative expression</a:t>
            </a:r>
          </a:p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vs 0h)</a:t>
            </a:r>
            <a:endParaRPr kumimoji="1" lang="en-US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281571" y="2534973"/>
            <a:ext cx="15215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alf-life</a:t>
            </a:r>
            <a:r>
              <a: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ET3</a:t>
            </a:r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E4B90186-4220-AB48-8C65-BFD7B764ABC6}"/>
              </a:ext>
            </a:extLst>
          </p:cNvPr>
          <p:cNvSpPr/>
          <p:nvPr/>
        </p:nvSpPr>
        <p:spPr>
          <a:xfrm>
            <a:off x="2852936" y="488504"/>
            <a:ext cx="90000" cy="9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21779A33-039A-EE44-B02C-A25A2D1B3ECB}"/>
              </a:ext>
            </a:extLst>
          </p:cNvPr>
          <p:cNvSpPr/>
          <p:nvPr/>
        </p:nvSpPr>
        <p:spPr>
          <a:xfrm>
            <a:off x="2852936" y="686536"/>
            <a:ext cx="90000" cy="90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3BB7EB9-DB0E-3D42-84F1-833593069F46}"/>
              </a:ext>
            </a:extLst>
          </p:cNvPr>
          <p:cNvSpPr txBox="1"/>
          <p:nvPr/>
        </p:nvSpPr>
        <p:spPr>
          <a:xfrm>
            <a:off x="2926019" y="416496"/>
            <a:ext cx="5790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604642B-05F4-734D-A768-DE24A505F925}"/>
              </a:ext>
            </a:extLst>
          </p:cNvPr>
          <p:cNvSpPr txBox="1"/>
          <p:nvPr/>
        </p:nvSpPr>
        <p:spPr>
          <a:xfrm>
            <a:off x="2926019" y="602323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A924815-94BA-E741-A6E7-A03C98F1B25C}"/>
              </a:ext>
            </a:extLst>
          </p:cNvPr>
          <p:cNvSpPr txBox="1"/>
          <p:nvPr/>
        </p:nvSpPr>
        <p:spPr>
          <a:xfrm>
            <a:off x="555841" y="212603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9404594-7BE7-9E40-9B3A-7CC842737733}"/>
              </a:ext>
            </a:extLst>
          </p:cNvPr>
          <p:cNvSpPr txBox="1"/>
          <p:nvPr/>
        </p:nvSpPr>
        <p:spPr>
          <a:xfrm>
            <a:off x="555841" y="84854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1FFF530-B090-3F4B-8425-F7EF6EC4E2CB}"/>
              </a:ext>
            </a:extLst>
          </p:cNvPr>
          <p:cNvSpPr txBox="1"/>
          <p:nvPr/>
        </p:nvSpPr>
        <p:spPr>
          <a:xfrm>
            <a:off x="450043" y="148728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74ED765-0E05-814B-A8A3-621C8019A2AE}"/>
              </a:ext>
            </a:extLst>
          </p:cNvPr>
          <p:cNvSpPr txBox="1"/>
          <p:nvPr/>
        </p:nvSpPr>
        <p:spPr>
          <a:xfrm>
            <a:off x="941554" y="228870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6C08690-1BDF-BC42-ACF2-BC4D2DA06228}"/>
              </a:ext>
            </a:extLst>
          </p:cNvPr>
          <p:cNvSpPr txBox="1"/>
          <p:nvPr/>
        </p:nvSpPr>
        <p:spPr>
          <a:xfrm>
            <a:off x="1372388" y="228870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56C2166-CFB9-2246-8FD7-609C67BFCC86}"/>
              </a:ext>
            </a:extLst>
          </p:cNvPr>
          <p:cNvSpPr txBox="1"/>
          <p:nvPr/>
        </p:nvSpPr>
        <p:spPr>
          <a:xfrm>
            <a:off x="1932445" y="228870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8A8B71C-7E06-F746-AB99-EE3F0F0A4A54}"/>
              </a:ext>
            </a:extLst>
          </p:cNvPr>
          <p:cNvSpPr txBox="1"/>
          <p:nvPr/>
        </p:nvSpPr>
        <p:spPr>
          <a:xfrm>
            <a:off x="2426840" y="228870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385D0C8-D566-CC45-AC4C-D3B559631691}"/>
              </a:ext>
            </a:extLst>
          </p:cNvPr>
          <p:cNvSpPr txBox="1"/>
          <p:nvPr/>
        </p:nvSpPr>
        <p:spPr>
          <a:xfrm>
            <a:off x="2923454" y="228870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02589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07213C5-8957-804E-880C-F7C2C43EB3F3}"/>
              </a:ext>
            </a:extLst>
          </p:cNvPr>
          <p:cNvSpPr txBox="1"/>
          <p:nvPr/>
        </p:nvSpPr>
        <p:spPr>
          <a:xfrm>
            <a:off x="629987" y="184565"/>
            <a:ext cx="19816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 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80A97D5-883C-2C47-AED4-0726558ED2B2}"/>
              </a:ext>
            </a:extLst>
          </p:cNvPr>
          <p:cNvSpPr txBox="1"/>
          <p:nvPr/>
        </p:nvSpPr>
        <p:spPr>
          <a:xfrm rot="16200000">
            <a:off x="509619" y="1498878"/>
            <a:ext cx="1521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elative expression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3D95267-2124-4047-A528-37A2F57EAB00}"/>
              </a:ext>
            </a:extLst>
          </p:cNvPr>
          <p:cNvSpPr txBox="1"/>
          <p:nvPr/>
        </p:nvSpPr>
        <p:spPr>
          <a:xfrm>
            <a:off x="1113631" y="52546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FA132987-18C8-CF4E-B0D9-CE668F580C97}"/>
              </a:ext>
            </a:extLst>
          </p:cNvPr>
          <p:cNvSpPr/>
          <p:nvPr/>
        </p:nvSpPr>
        <p:spPr>
          <a:xfrm>
            <a:off x="3447725" y="749539"/>
            <a:ext cx="72000" cy="72000"/>
          </a:xfrm>
          <a:prstGeom prst="rect">
            <a:avLst/>
          </a:prstGeom>
          <a:noFill/>
          <a:ln w="952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FA2243E-4F35-A446-88D8-03764A1F1F52}"/>
              </a:ext>
            </a:extLst>
          </p:cNvPr>
          <p:cNvSpPr txBox="1"/>
          <p:nvPr/>
        </p:nvSpPr>
        <p:spPr>
          <a:xfrm>
            <a:off x="3539018" y="630371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871481B4-A4E6-A441-ACF0-D71998A67F23}"/>
              </a:ext>
            </a:extLst>
          </p:cNvPr>
          <p:cNvSpPr/>
          <p:nvPr/>
        </p:nvSpPr>
        <p:spPr>
          <a:xfrm>
            <a:off x="3447725" y="946732"/>
            <a:ext cx="72000" cy="7200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062FA7E-F3B4-264C-939B-4C757B153FD1}"/>
              </a:ext>
            </a:extLst>
          </p:cNvPr>
          <p:cNvSpPr txBox="1"/>
          <p:nvPr/>
        </p:nvSpPr>
        <p:spPr>
          <a:xfrm>
            <a:off x="3538849" y="846395"/>
            <a:ext cx="5902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iTET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7AACEC7E-F003-E14D-A304-823D85D29CA6}"/>
              </a:ext>
            </a:extLst>
          </p:cNvPr>
          <p:cNvGrpSpPr/>
          <p:nvPr/>
        </p:nvGrpSpPr>
        <p:grpSpPr>
          <a:xfrm>
            <a:off x="1340768" y="632520"/>
            <a:ext cx="2322126" cy="2056143"/>
            <a:chOff x="1889894" y="3002019"/>
            <a:chExt cx="2322126" cy="2056143"/>
          </a:xfrm>
        </p:grpSpPr>
        <p:graphicFrame>
          <p:nvGraphicFramePr>
            <p:cNvPr id="4" name="グラフ 3">
              <a:extLst>
                <a:ext uri="{FF2B5EF4-FFF2-40B4-BE49-F238E27FC236}">
                  <a16:creationId xmlns:a16="http://schemas.microsoft.com/office/drawing/2014/main" id="{7648FA80-555B-7A40-9831-2F8639FE95F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25171808"/>
                </p:ext>
              </p:extLst>
            </p:nvPr>
          </p:nvGraphicFramePr>
          <p:xfrm>
            <a:off x="1978293" y="3002019"/>
            <a:ext cx="2233727" cy="20044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1F449AF5-66B0-7641-93D8-8C599B89C3A8}"/>
                </a:ext>
              </a:extLst>
            </p:cNvPr>
            <p:cNvSpPr txBox="1"/>
            <p:nvPr/>
          </p:nvSpPr>
          <p:spPr>
            <a:xfrm>
              <a:off x="2326242" y="4811941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TET1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32D8AB7F-F861-5342-8695-322FE317A5DD}"/>
                </a:ext>
              </a:extLst>
            </p:cNvPr>
            <p:cNvSpPr txBox="1"/>
            <p:nvPr/>
          </p:nvSpPr>
          <p:spPr>
            <a:xfrm>
              <a:off x="2931516" y="4811940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TET2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3CDCB332-0714-C847-AD92-50E80CA21F07}"/>
                </a:ext>
              </a:extLst>
            </p:cNvPr>
            <p:cNvSpPr txBox="1"/>
            <p:nvPr/>
          </p:nvSpPr>
          <p:spPr>
            <a:xfrm>
              <a:off x="3536790" y="4811940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TET3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B0222128-F907-7242-9881-682F0291C134}"/>
                </a:ext>
              </a:extLst>
            </p:cNvPr>
            <p:cNvSpPr txBox="1"/>
            <p:nvPr/>
          </p:nvSpPr>
          <p:spPr>
            <a:xfrm>
              <a:off x="1995692" y="326661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ECDCFD1-1CD8-7749-9865-66C6798F431F}"/>
                </a:ext>
              </a:extLst>
            </p:cNvPr>
            <p:cNvSpPr txBox="1"/>
            <p:nvPr/>
          </p:nvSpPr>
          <p:spPr>
            <a:xfrm>
              <a:off x="1889894" y="3914691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0E9D6DA5-D8AF-0442-A1AC-1810CBBEE2EE}"/>
                </a:ext>
              </a:extLst>
            </p:cNvPr>
            <p:cNvSpPr txBox="1"/>
            <p:nvPr/>
          </p:nvSpPr>
          <p:spPr>
            <a:xfrm>
              <a:off x="1995692" y="456571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A8634F1-DE73-8238-7BDA-A3C10D1FEEE5}"/>
              </a:ext>
            </a:extLst>
          </p:cNvPr>
          <p:cNvSpPr txBox="1"/>
          <p:nvPr/>
        </p:nvSpPr>
        <p:spPr>
          <a:xfrm>
            <a:off x="1117502" y="279276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0BCD488-1C6C-961D-E006-442C6B4ECC38}"/>
              </a:ext>
            </a:extLst>
          </p:cNvPr>
          <p:cNvSpPr txBox="1"/>
          <p:nvPr/>
        </p:nvSpPr>
        <p:spPr>
          <a:xfrm rot="-2700000">
            <a:off x="1787164" y="3137872"/>
            <a:ext cx="5629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F2FCBEA-FCA4-81DA-9CD8-74D035CABA03}"/>
              </a:ext>
            </a:extLst>
          </p:cNvPr>
          <p:cNvSpPr txBox="1"/>
          <p:nvPr/>
        </p:nvSpPr>
        <p:spPr>
          <a:xfrm rot="-2700000">
            <a:off x="2132575" y="3122443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iTET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5B41446-0652-24AB-9720-F38BB2AECCD1}"/>
              </a:ext>
            </a:extLst>
          </p:cNvPr>
          <p:cNvSpPr txBox="1"/>
          <p:nvPr/>
        </p:nvSpPr>
        <p:spPr>
          <a:xfrm>
            <a:off x="2575712" y="3611270"/>
            <a:ext cx="5309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ET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3885A79-0DD1-6347-9CEE-170B37AFC6AA}"/>
              </a:ext>
            </a:extLst>
          </p:cNvPr>
          <p:cNvSpPr txBox="1"/>
          <p:nvPr/>
        </p:nvSpPr>
        <p:spPr>
          <a:xfrm>
            <a:off x="2575712" y="4259342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19B57AA-AA63-7D93-0B71-22888C90006A}"/>
              </a:ext>
            </a:extLst>
          </p:cNvPr>
          <p:cNvSpPr txBox="1"/>
          <p:nvPr/>
        </p:nvSpPr>
        <p:spPr>
          <a:xfrm>
            <a:off x="1401303" y="3611270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EBE249E-8382-A2D3-F40C-C4CA721D5720}"/>
              </a:ext>
            </a:extLst>
          </p:cNvPr>
          <p:cNvSpPr txBox="1"/>
          <p:nvPr/>
        </p:nvSpPr>
        <p:spPr>
          <a:xfrm>
            <a:off x="1479851" y="424825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F8CF8DE-578F-F55A-94BC-A2A583BEB106}"/>
              </a:ext>
            </a:extLst>
          </p:cNvPr>
          <p:cNvSpPr txBox="1"/>
          <p:nvPr/>
        </p:nvSpPr>
        <p:spPr>
          <a:xfrm>
            <a:off x="1315512" y="3277304"/>
            <a:ext cx="5293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図 30">
            <a:extLst>
              <a:ext uri="{FF2B5EF4-FFF2-40B4-BE49-F238E27FC236}">
                <a16:creationId xmlns:a16="http://schemas.microsoft.com/office/drawing/2014/main" id="{1FD1F8D2-A67B-70EF-EEBC-288AB010B4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83049" y="3497766"/>
            <a:ext cx="828571" cy="542857"/>
          </a:xfrm>
          <a:prstGeom prst="rect">
            <a:avLst/>
          </a:prstGeom>
          <a:ln>
            <a:noFill/>
          </a:ln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1E33AAE4-B99E-2690-3E6D-BC1591C6D2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92921" y="4112391"/>
            <a:ext cx="818699" cy="520990"/>
          </a:xfrm>
          <a:prstGeom prst="rect">
            <a:avLst/>
          </a:prstGeom>
        </p:spPr>
      </p:pic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84AF6330-C1F5-C558-CD6A-41273AF6505F}"/>
              </a:ext>
            </a:extLst>
          </p:cNvPr>
          <p:cNvSpPr/>
          <p:nvPr/>
        </p:nvSpPr>
        <p:spPr>
          <a:xfrm>
            <a:off x="1783049" y="3497766"/>
            <a:ext cx="828571" cy="52099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5AB80D2E-AB82-8B87-C2F3-26836710001C}"/>
              </a:ext>
            </a:extLst>
          </p:cNvPr>
          <p:cNvSpPr/>
          <p:nvPr/>
        </p:nvSpPr>
        <p:spPr>
          <a:xfrm>
            <a:off x="1792921" y="4121202"/>
            <a:ext cx="828571" cy="52099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95307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EF3394D-44F8-6346-ABDA-C2315D4F3A19}"/>
              </a:ext>
            </a:extLst>
          </p:cNvPr>
          <p:cNvSpPr txBox="1"/>
          <p:nvPr/>
        </p:nvSpPr>
        <p:spPr>
          <a:xfrm>
            <a:off x="629987" y="184565"/>
            <a:ext cx="19816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3 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37DD91D1-2F84-AF41-BD53-D833E6254832}"/>
              </a:ext>
            </a:extLst>
          </p:cNvPr>
          <p:cNvGrpSpPr/>
          <p:nvPr/>
        </p:nvGrpSpPr>
        <p:grpSpPr>
          <a:xfrm>
            <a:off x="2684951" y="650614"/>
            <a:ext cx="1680866" cy="487032"/>
            <a:chOff x="4437112" y="866354"/>
            <a:chExt cx="1680866" cy="487032"/>
          </a:xfrm>
        </p:grpSpPr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B312EFAB-2F38-174E-BD93-0ABFC9E396B3}"/>
                </a:ext>
              </a:extLst>
            </p:cNvPr>
            <p:cNvSpPr/>
            <p:nvPr/>
          </p:nvSpPr>
          <p:spPr>
            <a:xfrm>
              <a:off x="4437112" y="934206"/>
              <a:ext cx="108000" cy="108000"/>
            </a:xfrm>
            <a:prstGeom prst="rect">
              <a:avLst/>
            </a:prstGeom>
            <a:solidFill>
              <a:srgbClr val="1562C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C31CE617-6855-0147-87D5-F3DBBE3C8BCC}"/>
                </a:ext>
              </a:extLst>
            </p:cNvPr>
            <p:cNvSpPr/>
            <p:nvPr/>
          </p:nvSpPr>
          <p:spPr>
            <a:xfrm>
              <a:off x="4437112" y="1186246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4099C821-CB7E-8942-A64E-1430B0D3075A}"/>
                </a:ext>
              </a:extLst>
            </p:cNvPr>
            <p:cNvSpPr/>
            <p:nvPr/>
          </p:nvSpPr>
          <p:spPr>
            <a:xfrm>
              <a:off x="4545112" y="866354"/>
              <a:ext cx="157286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control siRNA/TNF(–) </a:t>
              </a:r>
              <a:endParaRPr lang="ja-JP" altLang="en-US" sz="1100"/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834FA9E6-9590-B64C-BC20-B60353B9FF90}"/>
                </a:ext>
              </a:extLst>
            </p:cNvPr>
            <p:cNvSpPr/>
            <p:nvPr/>
          </p:nvSpPr>
          <p:spPr>
            <a:xfrm>
              <a:off x="4541906" y="1091776"/>
              <a:ext cx="1576072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control siRNA/TNF(+) </a:t>
              </a:r>
              <a:endParaRPr lang="ja-JP" altLang="en-US" sz="1100"/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9F44CB1A-833F-EE4A-8C25-4F64EAE93FEE}"/>
              </a:ext>
            </a:extLst>
          </p:cNvPr>
          <p:cNvGrpSpPr/>
          <p:nvPr/>
        </p:nvGrpSpPr>
        <p:grpSpPr>
          <a:xfrm>
            <a:off x="4437112" y="632520"/>
            <a:ext cx="1442020" cy="523220"/>
            <a:chOff x="4437112" y="1357540"/>
            <a:chExt cx="1442020" cy="523220"/>
          </a:xfrm>
        </p:grpSpPr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FDB87E44-3E64-F645-996D-38C074FDEB78}"/>
                </a:ext>
              </a:extLst>
            </p:cNvPr>
            <p:cNvSpPr/>
            <p:nvPr/>
          </p:nvSpPr>
          <p:spPr>
            <a:xfrm>
              <a:off x="4437112" y="1690302"/>
              <a:ext cx="108000" cy="108000"/>
            </a:xfrm>
            <a:prstGeom prst="rect">
              <a:avLst/>
            </a:prstGeom>
            <a:solidFill>
              <a:schemeClr val="accent3">
                <a:lumMod val="5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1869D234-16CA-D348-BE37-EF1C6CA0BDA7}"/>
                </a:ext>
              </a:extLst>
            </p:cNvPr>
            <p:cNvSpPr/>
            <p:nvPr/>
          </p:nvSpPr>
          <p:spPr>
            <a:xfrm>
              <a:off x="4437112" y="1438262"/>
              <a:ext cx="108000" cy="108000"/>
            </a:xfrm>
            <a:prstGeom prst="rect">
              <a:avLst/>
            </a:prstGeom>
            <a:solidFill>
              <a:srgbClr val="7030A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77D767F6-810D-A049-88BD-0BD05864EE73}"/>
                </a:ext>
              </a:extLst>
            </p:cNvPr>
            <p:cNvSpPr/>
            <p:nvPr/>
          </p:nvSpPr>
          <p:spPr>
            <a:xfrm>
              <a:off x="4541906" y="1357540"/>
              <a:ext cx="133722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TET3</a:t>
              </a:r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-KD/TNF(–) </a:t>
              </a:r>
              <a:endParaRPr lang="ja-JP" altLang="en-US" sz="1100"/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9D0CFE95-AF69-FF40-B0A6-9DE5FE926DD8}"/>
                </a:ext>
              </a:extLst>
            </p:cNvPr>
            <p:cNvSpPr/>
            <p:nvPr/>
          </p:nvSpPr>
          <p:spPr>
            <a:xfrm>
              <a:off x="4543472" y="1619150"/>
              <a:ext cx="130195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TET3</a:t>
              </a:r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-KD/TNF(+)</a:t>
              </a:r>
              <a:endParaRPr lang="ja-JP" altLang="en-US" sz="1100"/>
            </a:p>
          </p:txBody>
        </p:sp>
      </p:grpSp>
      <p:pic>
        <p:nvPicPr>
          <p:cNvPr id="15" name="図 14">
            <a:extLst>
              <a:ext uri="{FF2B5EF4-FFF2-40B4-BE49-F238E27FC236}">
                <a16:creationId xmlns:a16="http://schemas.microsoft.com/office/drawing/2014/main" id="{B2E29508-C36C-FE47-BBFF-2A1FFA5E185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888" y="1496616"/>
            <a:ext cx="6661712" cy="7134898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5819C431-093C-E84E-9AF8-326A3C6A6051}"/>
              </a:ext>
            </a:extLst>
          </p:cNvPr>
          <p:cNvSpPr/>
          <p:nvPr/>
        </p:nvSpPr>
        <p:spPr>
          <a:xfrm>
            <a:off x="6165304" y="2936776"/>
            <a:ext cx="619192" cy="936104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37240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CFCB103-6DF0-4B1A-D35C-347F742E62DF}"/>
              </a:ext>
            </a:extLst>
          </p:cNvPr>
          <p:cNvSpPr txBox="1"/>
          <p:nvPr/>
        </p:nvSpPr>
        <p:spPr>
          <a:xfrm>
            <a:off x="629987" y="184565"/>
            <a:ext cx="19816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 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4AE03995-CE84-7B38-E254-C593BAD8DDE6}"/>
              </a:ext>
            </a:extLst>
          </p:cNvPr>
          <p:cNvCxnSpPr>
            <a:cxnSpLocks/>
          </p:cNvCxnSpPr>
          <p:nvPr/>
        </p:nvCxnSpPr>
        <p:spPr>
          <a:xfrm>
            <a:off x="2237598" y="2651852"/>
            <a:ext cx="226236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9427C758-6362-89E6-4251-202B5107354B}"/>
              </a:ext>
            </a:extLst>
          </p:cNvPr>
          <p:cNvCxnSpPr>
            <a:cxnSpLocks/>
          </p:cNvCxnSpPr>
          <p:nvPr/>
        </p:nvCxnSpPr>
        <p:spPr>
          <a:xfrm flipV="1">
            <a:off x="2241458" y="1167767"/>
            <a:ext cx="0" cy="14802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1A47B59-3E0A-AF48-D532-46A171BE6F05}"/>
              </a:ext>
            </a:extLst>
          </p:cNvPr>
          <p:cNvSpPr txBox="1"/>
          <p:nvPr/>
        </p:nvSpPr>
        <p:spPr>
          <a:xfrm>
            <a:off x="2042054" y="2508391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C51483C-33B7-D988-D699-712960F3C0F0}"/>
              </a:ext>
            </a:extLst>
          </p:cNvPr>
          <p:cNvSpPr txBox="1"/>
          <p:nvPr/>
        </p:nvSpPr>
        <p:spPr>
          <a:xfrm>
            <a:off x="1965110" y="178114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AE995DF-7298-CE09-69C6-9416904A4CF6}"/>
              </a:ext>
            </a:extLst>
          </p:cNvPr>
          <p:cNvSpPr txBox="1"/>
          <p:nvPr/>
        </p:nvSpPr>
        <p:spPr>
          <a:xfrm>
            <a:off x="1965110" y="105523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99D5D64-AF57-15ED-35FA-C11DC641944C}"/>
              </a:ext>
            </a:extLst>
          </p:cNvPr>
          <p:cNvSpPr txBox="1"/>
          <p:nvPr/>
        </p:nvSpPr>
        <p:spPr>
          <a:xfrm>
            <a:off x="2115179" y="2602700"/>
            <a:ext cx="26276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0               1                3               7 (day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201224A7-7339-F31D-F9F9-746E8E94AC0C}"/>
              </a:ext>
            </a:extLst>
          </p:cNvPr>
          <p:cNvCxnSpPr/>
          <p:nvPr/>
        </p:nvCxnSpPr>
        <p:spPr>
          <a:xfrm>
            <a:off x="3463400" y="1121577"/>
            <a:ext cx="4549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楕円 13">
            <a:extLst>
              <a:ext uri="{FF2B5EF4-FFF2-40B4-BE49-F238E27FC236}">
                <a16:creationId xmlns:a16="http://schemas.microsoft.com/office/drawing/2014/main" id="{06DDFA2C-F65B-34C7-2186-8861AAF78539}"/>
              </a:ext>
            </a:extLst>
          </p:cNvPr>
          <p:cNvSpPr/>
          <p:nvPr/>
        </p:nvSpPr>
        <p:spPr>
          <a:xfrm>
            <a:off x="3646497" y="1059431"/>
            <a:ext cx="118742" cy="133165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3DED76E-8A93-5F05-7CFF-35D0BECF01A8}"/>
              </a:ext>
            </a:extLst>
          </p:cNvPr>
          <p:cNvSpPr txBox="1"/>
          <p:nvPr/>
        </p:nvSpPr>
        <p:spPr>
          <a:xfrm>
            <a:off x="3882152" y="992560"/>
            <a:ext cx="5549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siCTL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96D3899E-900F-F9AC-A010-2D4BC352966A}"/>
              </a:ext>
            </a:extLst>
          </p:cNvPr>
          <p:cNvCxnSpPr/>
          <p:nvPr/>
        </p:nvCxnSpPr>
        <p:spPr>
          <a:xfrm>
            <a:off x="3466358" y="1346933"/>
            <a:ext cx="454975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楕円 19">
            <a:extLst>
              <a:ext uri="{FF2B5EF4-FFF2-40B4-BE49-F238E27FC236}">
                <a16:creationId xmlns:a16="http://schemas.microsoft.com/office/drawing/2014/main" id="{AC4A203E-4DE4-3E09-8B19-BE0C1398A349}"/>
              </a:ext>
            </a:extLst>
          </p:cNvPr>
          <p:cNvSpPr/>
          <p:nvPr/>
        </p:nvSpPr>
        <p:spPr>
          <a:xfrm>
            <a:off x="3649455" y="1284787"/>
            <a:ext cx="118742" cy="133165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207D64B-BB77-3FF8-D94C-B580685B71DB}"/>
              </a:ext>
            </a:extLst>
          </p:cNvPr>
          <p:cNvSpPr txBox="1"/>
          <p:nvPr/>
        </p:nvSpPr>
        <p:spPr>
          <a:xfrm>
            <a:off x="3882152" y="1217916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iTET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5C4BC56-FBF3-CB90-902D-276E6A955980}"/>
              </a:ext>
            </a:extLst>
          </p:cNvPr>
          <p:cNvSpPr txBox="1"/>
          <p:nvPr/>
        </p:nvSpPr>
        <p:spPr>
          <a:xfrm rot="16200000">
            <a:off x="1015752" y="1661167"/>
            <a:ext cx="168828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he cell number of FLS </a:t>
            </a: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             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x 10  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B4D067B-9373-3937-8726-29FE15B75622}"/>
              </a:ext>
            </a:extLst>
          </p:cNvPr>
          <p:cNvSpPr txBox="1"/>
          <p:nvPr/>
        </p:nvSpPr>
        <p:spPr>
          <a:xfrm rot="16200000">
            <a:off x="1767752" y="159576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00F4E0B9-08D9-5B20-047B-AA8B1004EE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9394897"/>
              </p:ext>
            </p:extLst>
          </p:nvPr>
        </p:nvGraphicFramePr>
        <p:xfrm>
          <a:off x="1772816" y="1021513"/>
          <a:ext cx="2928972" cy="17978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57082C3-7A81-4081-5315-DF1A2E2BA823}"/>
              </a:ext>
            </a:extLst>
          </p:cNvPr>
          <p:cNvSpPr txBox="1"/>
          <p:nvPr/>
        </p:nvSpPr>
        <p:spPr>
          <a:xfrm>
            <a:off x="3429000" y="2316514"/>
            <a:ext cx="7906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 0.03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F896945-706C-7DAA-E453-993E1154117E}"/>
              </a:ext>
            </a:extLst>
          </p:cNvPr>
          <p:cNvSpPr txBox="1"/>
          <p:nvPr/>
        </p:nvSpPr>
        <p:spPr>
          <a:xfrm>
            <a:off x="4088502" y="2140785"/>
            <a:ext cx="7906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= 0.028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246408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</Words>
  <Application>Microsoft Office PowerPoint</Application>
  <PresentationFormat>A4 210 x 297 mm</PresentationFormat>
  <Paragraphs>51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rial</vt:lpstr>
      <vt:lpstr>Calibri</vt:lpstr>
      <vt:lpstr>Symbol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Nakano Kazuhisa</dc:creator>
  <cp:keywords/>
  <dc:description/>
  <cp:lastModifiedBy>yamagata kaoru</cp:lastModifiedBy>
  <cp:revision>388</cp:revision>
  <cp:lastPrinted>2020-02-11T21:19:03Z</cp:lastPrinted>
  <dcterms:created xsi:type="dcterms:W3CDTF">2016-01-12T08:47:44Z</dcterms:created>
  <dcterms:modified xsi:type="dcterms:W3CDTF">2022-07-29T07:01:19Z</dcterms:modified>
  <cp:category/>
</cp:coreProperties>
</file>